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1" r:id="rId3"/>
    <p:sldId id="259" r:id="rId4"/>
    <p:sldId id="260" r:id="rId5"/>
    <p:sldId id="262" r:id="rId6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89" autoAdjust="0"/>
    <p:restoredTop sz="94719"/>
  </p:normalViewPr>
  <p:slideViewPr>
    <p:cSldViewPr>
      <p:cViewPr varScale="1">
        <p:scale>
          <a:sx n="61" d="100"/>
          <a:sy n="61" d="100"/>
        </p:scale>
        <p:origin x="1951" y="45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1626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5683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286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9632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2056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8663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5618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1138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0317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25760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4570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40C2E4-E50F-4F56-A527-3A87A6C91A71}" type="datetimeFigureOut">
              <a:rPr lang="ko-KR" altLang="en-US" smtClean="0"/>
              <a:t>2019-06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ABB5F-EDBC-4BF0-ADE3-AB8A7647EB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781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55886" y="1107150"/>
            <a:ext cx="2495100" cy="161936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10561" y="899592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610781" y="905942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2586" y="931635"/>
            <a:ext cx="2729395" cy="5013270"/>
          </a:xfrm>
          <a:prstGeom prst="rect">
            <a:avLst/>
          </a:prstGeom>
        </p:spPr>
      </p:pic>
      <p:sp>
        <p:nvSpPr>
          <p:cNvPr id="3" name="직사각형 2"/>
          <p:cNvSpPr/>
          <p:nvPr/>
        </p:nvSpPr>
        <p:spPr>
          <a:xfrm>
            <a:off x="404088" y="6309157"/>
            <a:ext cx="6192688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</a:t>
            </a:r>
            <a:r>
              <a:rPr lang="ko-KR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arch for differentially expressed miRNAs between PC14PE6 and PC14PE6/</a:t>
            </a:r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vBr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s by microarray. </a:t>
            </a:r>
            <a:r>
              <a:rPr lang="en-US" altLang="ko-KR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</a:t>
            </a:r>
            <a:r>
              <a:rPr lang="en-US" altLang="ko-KR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altLang="ko-KR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r>
              <a:rPr lang="en-US" altLang="ko-KR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croarray analysis was performed to identify miRNA candidates. </a:t>
            </a:r>
            <a:r>
              <a:rPr lang="en-US" altLang="ko-KR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atmap</a:t>
            </a:r>
            <a:r>
              <a:rPr lang="en-US" altLang="ko-KR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dicate </a:t>
            </a:r>
            <a:r>
              <a:rPr lang="en-US" altLang="ko-KR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downregulation of miRNAs in metastatic lung cancer cells (PC14PE6/LvBr4) obtained from two independent </a:t>
            </a:r>
            <a:r>
              <a:rPr lang="en-US" altLang="ko-KR" sz="12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plicates. Number </a:t>
            </a:r>
            <a:r>
              <a:rPr lang="en-US" altLang="ko-KR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 Figure 1A is the fold change of miRNA expression level (Log2_Ratio_PC14PE6/LvBr4 vs PC14PE6). ‘</a:t>
            </a:r>
            <a:r>
              <a:rPr lang="en-US" altLang="ko-KR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sa</a:t>
            </a:r>
            <a:r>
              <a:rPr lang="en-US" altLang="ko-KR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’ means that miRNAs belong to a human (Homo sapiens). (</a:t>
            </a:r>
            <a:r>
              <a:rPr lang="en-US" altLang="ko-KR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</a:t>
            </a:r>
            <a:r>
              <a:rPr lang="en-US" altLang="ko-KR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lative levels of miR-193b-3p and -5p in microarray data were shown. Bars indicate the average of miRNA level from two independent replicates.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4DBCD0B-BA74-E648-9E2D-F21109A18340}"/>
              </a:ext>
            </a:extLst>
          </p:cNvPr>
          <p:cNvSpPr txBox="1"/>
          <p:nvPr/>
        </p:nvSpPr>
        <p:spPr>
          <a:xfrm>
            <a:off x="218360" y="170803"/>
            <a:ext cx="6496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					   Choi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69565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658" y="1268270"/>
            <a:ext cx="6270184" cy="47438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4DBCD0B-BA74-E648-9E2D-F21109A18340}"/>
              </a:ext>
            </a:extLst>
          </p:cNvPr>
          <p:cNvSpPr txBox="1"/>
          <p:nvPr/>
        </p:nvSpPr>
        <p:spPr>
          <a:xfrm>
            <a:off x="218360" y="170803"/>
            <a:ext cx="6496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					   Choi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3D1331A-0ACC-2342-B3AA-809FE49C58B0}"/>
              </a:ext>
            </a:extLst>
          </p:cNvPr>
          <p:cNvSpPr txBox="1"/>
          <p:nvPr/>
        </p:nvSpPr>
        <p:spPr>
          <a:xfrm>
            <a:off x="218360" y="6364649"/>
            <a:ext cx="64968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earch for common target genes of miR-193b-3p and -5p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he Venn diagram indicates the target gene list of miR-193b-3p and -5p as predicted by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TargetScan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Common target genes including CCND1, AJUBA, and HEG1 were selected by comparison with the genes targeted by miR-193b-3p and -5p and those whose expression was decreased in metastatic PC14PE6/LvBr4 cells compared to those in parental PC14PE6 cells.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22779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/>
          <p:cNvGrpSpPr/>
          <p:nvPr/>
        </p:nvGrpSpPr>
        <p:grpSpPr>
          <a:xfrm>
            <a:off x="1242358" y="1284136"/>
            <a:ext cx="4202866" cy="4151960"/>
            <a:chOff x="1338116" y="971600"/>
            <a:chExt cx="4202866" cy="4151960"/>
          </a:xfrm>
        </p:grpSpPr>
        <p:grpSp>
          <p:nvGrpSpPr>
            <p:cNvPr id="2" name="그룹 1"/>
            <p:cNvGrpSpPr/>
            <p:nvPr/>
          </p:nvGrpSpPr>
          <p:grpSpPr>
            <a:xfrm>
              <a:off x="1338116" y="971600"/>
              <a:ext cx="4202866" cy="2213921"/>
              <a:chOff x="1338116" y="971600"/>
              <a:chExt cx="4202866" cy="2213921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8533"/>
              <a:stretch/>
            </p:blipFill>
            <p:spPr bwMode="auto">
              <a:xfrm>
                <a:off x="3173929" y="971600"/>
                <a:ext cx="2367053" cy="196708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97491" y="1101069"/>
                <a:ext cx="1346202" cy="208445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1338116" y="971600"/>
                <a:ext cx="4320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2874034" y="971600"/>
                <a:ext cx="43204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  <a:endPara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47" r="14273"/>
            <a:stretch/>
          </p:blipFill>
          <p:spPr bwMode="auto">
            <a:xfrm>
              <a:off x="1497412" y="3424936"/>
              <a:ext cx="1711884" cy="16986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3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401" r="13897"/>
            <a:stretch/>
          </p:blipFill>
          <p:spPr bwMode="auto">
            <a:xfrm>
              <a:off x="3429961" y="3388951"/>
              <a:ext cx="1733169" cy="17234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1338116" y="3158262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284984" y="3161530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44DBCD0B-BA74-E648-9E2D-F21109A18340}"/>
              </a:ext>
            </a:extLst>
          </p:cNvPr>
          <p:cNvSpPr txBox="1"/>
          <p:nvPr/>
        </p:nvSpPr>
        <p:spPr>
          <a:xfrm>
            <a:off x="218360" y="170803"/>
            <a:ext cx="6496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					   Choi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772D027-0F45-F941-954F-AB92992D248A}"/>
              </a:ext>
            </a:extLst>
          </p:cNvPr>
          <p:cNvSpPr txBox="1"/>
          <p:nvPr/>
        </p:nvSpPr>
        <p:spPr>
          <a:xfrm>
            <a:off x="218360" y="5796136"/>
            <a:ext cx="6496881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</a:t>
            </a:r>
            <a:r>
              <a:rPr lang="ko-KR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MP16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is required for invasiveness of PC14PE6/LvBr4 cells, but is not a target of miR-193b-3p or -5p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Comparison of the expression level of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MMP16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between metastatic PC14PE6/LvBr4 and parental PC14PE6 cells. (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PC14PE6/LvBr4 cells were transfected with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MMP16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specific siRNA and invasiveness was determined by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well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invasion assay. (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To determine whether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MMP16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is a direct target of miR-193b-3p or -5p, the enrichment of MMP16 mRNA in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Argonaute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2-RNA immunoprecipitation (Ago2-RIP) material was assessed after overexpression of miR-193b-3p or -5p in PC14PE6/LvBr4 cells. (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PC14PE6/LvBr4 cells were transfected with miRNA mimics and the expression level of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MMP16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mRNA was determined by RT-qPCR. All experiments were performed three times and data represent mean ± standard deviation (SD). Asterisk (*) denotes statistical significance of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&lt; 0.05 calculated with the Student’s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test.</a:t>
            </a:r>
            <a:r>
              <a:rPr lang="ko-K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9104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358" y="2771188"/>
            <a:ext cx="3201076" cy="17080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6842" y="2775671"/>
            <a:ext cx="3216620" cy="17080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147" y="1155191"/>
            <a:ext cx="2686307" cy="12078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7162" y="1160722"/>
            <a:ext cx="2685393" cy="12078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96160" y="1121499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01160" y="2703235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77500" y="1110135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482500" y="2732815"/>
            <a:ext cx="432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4DBCD0B-BA74-E648-9E2D-F21109A18340}"/>
              </a:ext>
            </a:extLst>
          </p:cNvPr>
          <p:cNvSpPr txBox="1"/>
          <p:nvPr/>
        </p:nvSpPr>
        <p:spPr>
          <a:xfrm>
            <a:off x="218360" y="170803"/>
            <a:ext cx="6496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					   Choi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9762484-DBE1-B543-9F67-6A38E67948CC}"/>
              </a:ext>
            </a:extLst>
          </p:cNvPr>
          <p:cNvSpPr txBox="1"/>
          <p:nvPr/>
        </p:nvSpPr>
        <p:spPr>
          <a:xfrm>
            <a:off x="96159" y="4914037"/>
            <a:ext cx="661908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.</a:t>
            </a:r>
            <a:r>
              <a:rPr lang="ko-KR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Specific siRNAs targeting CCND1, AJUBA, and HEG1 efficiently downregulate their expression.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PC14PE6/LvBr4 (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) and A549 (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) cells were transfected with the indicated siRNAs and the protein and mRNA expression levels of the target gene were assessed by Western blot (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) and RT-qPCR (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) analyses. All experiments were performed three times and data represent mean ± standard deviation (SD).</a:t>
            </a:r>
          </a:p>
        </p:txBody>
      </p:sp>
    </p:spTree>
    <p:extLst>
      <p:ext uri="{BB962C8B-B14F-4D97-AF65-F5344CB8AC3E}">
        <p14:creationId xmlns:p14="http://schemas.microsoft.com/office/powerpoint/2010/main" val="18995228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/>
          <p:nvPr/>
        </p:nvPicPr>
        <p:blipFill>
          <a:blip r:embed="rId2"/>
          <a:stretch>
            <a:fillRect/>
          </a:stretch>
        </p:blipFill>
        <p:spPr>
          <a:xfrm>
            <a:off x="269750" y="1862303"/>
            <a:ext cx="6291729" cy="2304256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188640" y="971600"/>
            <a:ext cx="639077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. Verification of miRNA overexpression by miRNA mimic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fter PC14PE6/LvBr4 and A549 cells were transfected with miRNA mimics, the levels of miR-193b-3p and -5p in three independent replicates were assessed by RT-qPCR using specific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TaqMan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primers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178977D-EA1D-0145-9189-4EEFC9565603}"/>
              </a:ext>
            </a:extLst>
          </p:cNvPr>
          <p:cNvSpPr txBox="1"/>
          <p:nvPr/>
        </p:nvSpPr>
        <p:spPr>
          <a:xfrm>
            <a:off x="218360" y="170803"/>
            <a:ext cx="6496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					   Choi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8490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30</TotalTime>
  <Words>503</Words>
  <Application>Microsoft Office PowerPoint</Application>
  <PresentationFormat>화면 슬라이드 쇼(4:3)</PresentationFormat>
  <Paragraphs>20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9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eon Ho Kim</dc:creator>
  <cp:lastModifiedBy>Kim Hyeon Ho</cp:lastModifiedBy>
  <cp:revision>62</cp:revision>
  <dcterms:created xsi:type="dcterms:W3CDTF">2018-02-04T07:28:10Z</dcterms:created>
  <dcterms:modified xsi:type="dcterms:W3CDTF">2019-06-18T23:43:15Z</dcterms:modified>
</cp:coreProperties>
</file>